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402" r:id="rId3"/>
    <p:sldId id="2404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49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742BE6-901A-4AE4-AC96-4CE0AE73F5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67A9D1D-FAFA-4E65-9109-991E7F6C7D7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76D11F-95E5-4891-88AC-94BD6F90EC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B8625-3DD2-4414-8F8C-4553E053CB4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68D78B-6954-4744-8592-646E1518FD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D11936-B6E5-4CC1-B9F6-6438199F55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E91268-BC9B-4640-899E-1AEDB28CDA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797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E382E3-4709-4CE6-996C-E97010054D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CABCA9E-B5C2-42AE-B89F-546AD58B90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DEDBFD-92DE-4C4F-A84C-3E356AA58A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B8625-3DD2-4414-8F8C-4553E053CB4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00990C-A8E7-40B6-8387-32436E6501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C2C58E-D77E-4F7A-A5A2-36064F402D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E91268-BC9B-4640-899E-1AEDB28CDA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15590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0EFBE03-C5A2-4B2E-841B-C3575D9595F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FA8F234-9B27-4E6D-AD35-A500E16DAD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E99F92-CD5C-4765-8DE2-DF28BDFC1C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B8625-3DD2-4414-8F8C-4553E053CB4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3F3F22-D558-4C4D-9EC7-27ED80EC78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1355A2-FD4B-44FF-B075-3C30DE1452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E91268-BC9B-4640-899E-1AEDB28CDA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5369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E3B272-8BDB-4160-B815-603881F400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22F3127-E0B7-4958-84DC-C6BD3048D1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295303-68A7-493A-9706-B75EA38B09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B8625-3DD2-4414-8F8C-4553E053CB4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13F7E6-70A2-470E-96BC-C9B459CFA7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4BDE3E-44AB-4D9B-9502-889F085599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E91268-BC9B-4640-899E-1AEDB28CDA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22002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737203-A549-4F3B-9233-9954B6B980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70C94F9-6D5B-4AE6-BE4B-00F353E473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C9C2CA-BE99-4CE7-ABF7-C7A68E3421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B8625-3DD2-4414-8F8C-4553E053CB4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37169B-C8DE-41AC-B0CA-C4D4D58774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0DDA7F-C050-49DF-B1AB-5205132418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E91268-BC9B-4640-899E-1AEDB28CDA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56440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ECC5FB-83DE-4B74-9713-05838E9688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A77113-04A8-45CD-B150-F755512121D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2035C1-43C4-4AF2-9CFB-EBDD277EA8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9A2EC1-0AE5-44F4-BB33-511E025406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B8625-3DD2-4414-8F8C-4553E053CB4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C089645-98B9-4554-9399-98277FC13E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309FD02-2BFE-4714-A895-51E6DBA998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E91268-BC9B-4640-899E-1AEDB28CDA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8475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A840C7-D1C0-408F-B343-A483726A26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22037E-DA3D-4A48-8539-6847EB5A9D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09BDCA6-B28A-41E2-A1C3-1104500952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2D5089E-147E-4B92-8DC0-084C695E1A8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0B88B4C-95BF-4A1B-B3AA-A16FEA1F488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B82ECE-D08A-44EF-8322-3F789D3E56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B8625-3DD2-4414-8F8C-4553E053CB4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89EADE0-6B05-4810-A922-6597EEBCCE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07F004A-B456-4CE3-A64E-7E9955E766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E91268-BC9B-4640-899E-1AEDB28CDA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68522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7DB74F-F85D-416D-9E5B-08D30C0111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DA9012F-6B6F-4FFC-9580-282850E078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B8625-3DD2-4414-8F8C-4553E053CB4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4135B49-60FE-448E-A9A7-C0017952C7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CA35C4F-7BD9-4D56-AEEE-6A7F210C8B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E91268-BC9B-4640-899E-1AEDB28CDA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68448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F3703F6-2546-4A3B-9725-C2465D515E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B8625-3DD2-4414-8F8C-4553E053CB4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6612D66-AC74-4405-8A7F-684425CEC4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9A325ED-434B-4AEB-9C22-ECC91AF9A6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E91268-BC9B-4640-899E-1AEDB28CDA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94882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98C01E-DBD7-41A6-B729-8C84F49887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3286C8-AD80-40B5-AF40-AD2BE679202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C86EC0A-4412-4F2B-AF02-8F052DBEA1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FB718A-C3A8-40D3-AA1B-4E12145386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B8625-3DD2-4414-8F8C-4553E053CB4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D1D0B9C-30AC-4F24-B62B-97E88B6CA6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1976BEB-0B02-4F09-A6F0-5D85E60FDB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E91268-BC9B-4640-899E-1AEDB28CDA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86354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38180B-6736-4015-8A82-61438DFD56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95D3A57-7DA7-4FB0-8B8A-2B7563536EE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27D3691-3476-4E93-A1F0-F571FED112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BC7A4B-E17E-455B-98F0-5F832286AA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B8625-3DD2-4414-8F8C-4553E053CB4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E580218-950F-433A-A8DD-46900BF4E8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B05F7F-C7FF-477B-8E50-1EF472231D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E91268-BC9B-4640-899E-1AEDB28CDA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1987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03C3E37-6BEB-45FA-A14D-7E1F593D3C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3BA8B4-DA53-439A-B25E-52355038C5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3AAE97-BDA5-41D4-8E71-6EBBE8FBE49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EB8625-3DD2-4414-8F8C-4553E053CB4B}" type="datetimeFigureOut">
              <a:rPr lang="en-US" smtClean="0"/>
              <a:t>8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A03CC0-B3B1-46EA-94CA-1D9A7CB0D29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A1DEB3-6D9D-48AE-A502-213D73A2E89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E91268-BC9B-4640-899E-1AEDB28CDA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62567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:a16="http://schemas.microsoft.com/office/drawing/2014/main" id="{FBDE038F-9287-4493-860D-DE1D3B5BB61F}"/>
              </a:ext>
            </a:extLst>
          </p:cNvPr>
          <p:cNvGrpSpPr/>
          <p:nvPr/>
        </p:nvGrpSpPr>
        <p:grpSpPr>
          <a:xfrm>
            <a:off x="4560735" y="1409479"/>
            <a:ext cx="2176360" cy="2922470"/>
            <a:chOff x="4560735" y="1409479"/>
            <a:chExt cx="2176360" cy="2922470"/>
          </a:xfrm>
        </p:grpSpPr>
        <p:pic>
          <p:nvPicPr>
            <p:cNvPr id="3" name="그림 2" descr="텍스트이(가) 표시된 사진&#10;&#10;자동 생성된 설명">
              <a:extLst>
                <a:ext uri="{FF2B5EF4-FFF2-40B4-BE49-F238E27FC236}">
                  <a16:creationId xmlns:a16="http://schemas.microsoft.com/office/drawing/2014/main" id="{C9CFEDB4-5B31-4721-95A6-4F0736D994A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1163"/>
            <a:stretch/>
          </p:blipFill>
          <p:spPr>
            <a:xfrm>
              <a:off x="4560735" y="1811949"/>
              <a:ext cx="1813940" cy="2520000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4BCB663-108B-4F41-9E86-EEEF81884924}"/>
                </a:ext>
              </a:extLst>
            </p:cNvPr>
            <p:cNvSpPr txBox="1"/>
            <p:nvPr/>
          </p:nvSpPr>
          <p:spPr>
            <a:xfrm>
              <a:off x="4646458" y="1409479"/>
              <a:ext cx="209063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             </a:t>
              </a:r>
              <a:r>
                <a:rPr lang="en-US" altLang="ko-KR" sz="1000" u="sng" dirty="0">
                  <a:latin typeface="Arial" panose="020B0604020202020204" pitchFamily="34" charset="0"/>
                  <a:cs typeface="Arial" panose="020B0604020202020204" pitchFamily="34" charset="0"/>
                </a:rPr>
                <a:t>            4 DAI           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       </a:t>
              </a:r>
            </a:p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   M   R  N T10 T11 T12 T13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D630C453-ED0A-4ED4-A086-EB083B17FE83}"/>
              </a:ext>
            </a:extLst>
          </p:cNvPr>
          <p:cNvSpPr txBox="1"/>
          <p:nvPr/>
        </p:nvSpPr>
        <p:spPr>
          <a:xfrm>
            <a:off x="1262742" y="268180"/>
            <a:ext cx="6096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0" i="0" dirty="0">
                <a:solidFill>
                  <a:srgbClr val="1A1A1A"/>
                </a:solidFill>
                <a:effectLst/>
                <a:latin typeface="Arial" panose="020B0604020202020204" pitchFamily="34" charset="0"/>
              </a:rPr>
              <a:t>Supplementary material</a:t>
            </a:r>
          </a:p>
          <a:p>
            <a:r>
              <a:rPr lang="en-US" dirty="0">
                <a:solidFill>
                  <a:srgbClr val="1A1A1A"/>
                </a:solidFill>
                <a:latin typeface="Arial" panose="020B0604020202020204" pitchFamily="34" charset="0"/>
              </a:rPr>
              <a:t>Supplementary Figures</a:t>
            </a:r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DACDA13-50A4-470A-B441-EE6F9DBD4DA6}"/>
              </a:ext>
            </a:extLst>
          </p:cNvPr>
          <p:cNvSpPr txBox="1"/>
          <p:nvPr/>
        </p:nvSpPr>
        <p:spPr>
          <a:xfrm>
            <a:off x="574766" y="4750249"/>
            <a:ext cx="9222378" cy="172111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150000"/>
              </a:lnSpc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 Detection of p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lant-based SARS-CoV-2 RBD protein expressed in glycoengineered 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icotiana </a:t>
            </a:r>
            <a:r>
              <a:rPr lang="en-US" sz="12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enthamiana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using different constructs (T10, T11, T12, T13)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protein was extracted fro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 the tobacco leaves harvested 4 days post infiltration (4 DPI). The immunoblot membrane was probed with a rabbit polyclonal anti-SARS-CoV-2 (COVID-19) Spike RBD antibody. 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number below the protein band represents the densitometric intensity ratio of the protein in each lane.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bbreviations: M, protein size marker; R, 100ng of SARS-CoV-2 RBD protein from Expi293F cells (positive control); N, non-infiltrated (negative control)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D9E3526-9548-4640-935D-70609B7174B3}"/>
              </a:ext>
            </a:extLst>
          </p:cNvPr>
          <p:cNvSpPr txBox="1"/>
          <p:nvPr/>
        </p:nvSpPr>
        <p:spPr>
          <a:xfrm>
            <a:off x="4929052" y="3925205"/>
            <a:ext cx="15327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1.0    0.0     1.3       2.0    0.2   0.3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D4B3D26-375C-48EF-9CB1-28AB12B0D186}"/>
              </a:ext>
            </a:extLst>
          </p:cNvPr>
          <p:cNvSpPr txBox="1"/>
          <p:nvPr/>
        </p:nvSpPr>
        <p:spPr>
          <a:xfrm>
            <a:off x="4561170" y="239820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33E7C03-E399-4CE9-919E-24605DE80363}"/>
              </a:ext>
            </a:extLst>
          </p:cNvPr>
          <p:cNvSpPr txBox="1"/>
          <p:nvPr/>
        </p:nvSpPr>
        <p:spPr>
          <a:xfrm>
            <a:off x="4561170" y="2587468"/>
            <a:ext cx="3257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638F41D-E1A9-4FFD-BCD2-0130EEA1A3A4}"/>
              </a:ext>
            </a:extLst>
          </p:cNvPr>
          <p:cNvSpPr txBox="1"/>
          <p:nvPr/>
        </p:nvSpPr>
        <p:spPr>
          <a:xfrm>
            <a:off x="4561170" y="282660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1272B1E-6BC5-4B5E-BEEB-5066A952E7BE}"/>
              </a:ext>
            </a:extLst>
          </p:cNvPr>
          <p:cNvSpPr txBox="1"/>
          <p:nvPr/>
        </p:nvSpPr>
        <p:spPr>
          <a:xfrm>
            <a:off x="4525904" y="213634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E044BCD-728D-4A77-89CE-90D69B044524}"/>
              </a:ext>
            </a:extLst>
          </p:cNvPr>
          <p:cNvSpPr txBox="1"/>
          <p:nvPr/>
        </p:nvSpPr>
        <p:spPr>
          <a:xfrm>
            <a:off x="4525904" y="226010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직사각형 142">
            <a:extLst>
              <a:ext uri="{FF2B5EF4-FFF2-40B4-BE49-F238E27FC236}">
                <a16:creationId xmlns:a16="http://schemas.microsoft.com/office/drawing/2014/main" id="{486FE1BE-5CC3-4F2F-8F0B-B0AD373823F3}"/>
              </a:ext>
            </a:extLst>
          </p:cNvPr>
          <p:cNvSpPr/>
          <p:nvPr/>
        </p:nvSpPr>
        <p:spPr>
          <a:xfrm>
            <a:off x="4525904" y="2052301"/>
            <a:ext cx="35779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AAC8AB1-6D7D-4A3F-825D-A8998565CB86}"/>
              </a:ext>
            </a:extLst>
          </p:cNvPr>
          <p:cNvSpPr txBox="1"/>
          <p:nvPr/>
        </p:nvSpPr>
        <p:spPr>
          <a:xfrm>
            <a:off x="4561170" y="309606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DECCB6B-6137-4D30-96CC-D96413A6C342}"/>
              </a:ext>
            </a:extLst>
          </p:cNvPr>
          <p:cNvSpPr txBox="1"/>
          <p:nvPr/>
        </p:nvSpPr>
        <p:spPr>
          <a:xfrm>
            <a:off x="4565337" y="3490855"/>
            <a:ext cx="3257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F6F44A7-AC95-46D4-85BC-2EEE42167A69}"/>
              </a:ext>
            </a:extLst>
          </p:cNvPr>
          <p:cNvSpPr txBox="1"/>
          <p:nvPr/>
        </p:nvSpPr>
        <p:spPr>
          <a:xfrm>
            <a:off x="4561170" y="358376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직사각형 142">
            <a:extLst>
              <a:ext uri="{FF2B5EF4-FFF2-40B4-BE49-F238E27FC236}">
                <a16:creationId xmlns:a16="http://schemas.microsoft.com/office/drawing/2014/main" id="{96F68D11-0A52-4FFE-ACB3-55D271815CBB}"/>
              </a:ext>
            </a:extLst>
          </p:cNvPr>
          <p:cNvSpPr/>
          <p:nvPr/>
        </p:nvSpPr>
        <p:spPr>
          <a:xfrm>
            <a:off x="4525904" y="1827007"/>
            <a:ext cx="36740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80416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그림 9">
            <a:extLst>
              <a:ext uri="{FF2B5EF4-FFF2-40B4-BE49-F238E27FC236}">
                <a16:creationId xmlns:a16="http://schemas.microsoft.com/office/drawing/2014/main" id="{57B3E17A-F00F-4FF0-8E27-45A8C63E257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" r="23672"/>
          <a:stretch/>
        </p:blipFill>
        <p:spPr>
          <a:xfrm>
            <a:off x="3814219" y="1878876"/>
            <a:ext cx="1389302" cy="2520000"/>
          </a:xfrm>
          <a:prstGeom prst="rect">
            <a:avLst/>
          </a:prstGeom>
        </p:spPr>
      </p:pic>
      <p:pic>
        <p:nvPicPr>
          <p:cNvPr id="12" name="그림 11" descr="텍스트이(가) 표시된 사진&#10;&#10;자동 생성된 설명">
            <a:extLst>
              <a:ext uri="{FF2B5EF4-FFF2-40B4-BE49-F238E27FC236}">
                <a16:creationId xmlns:a16="http://schemas.microsoft.com/office/drawing/2014/main" id="{FF292315-B35A-4278-BF02-00A17D7CCD0E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427"/>
          <a:stretch/>
        </p:blipFill>
        <p:spPr>
          <a:xfrm>
            <a:off x="6651875" y="1895819"/>
            <a:ext cx="1455805" cy="252000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A454CED0-236D-4539-BD79-73C817C7B280}"/>
              </a:ext>
            </a:extLst>
          </p:cNvPr>
          <p:cNvSpPr txBox="1"/>
          <p:nvPr/>
        </p:nvSpPr>
        <p:spPr>
          <a:xfrm>
            <a:off x="3814219" y="1601877"/>
            <a:ext cx="16065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M      1      2     3     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34CE92A-F256-4E68-B000-00808FC33CEF}"/>
              </a:ext>
            </a:extLst>
          </p:cNvPr>
          <p:cNvSpPr txBox="1"/>
          <p:nvPr/>
        </p:nvSpPr>
        <p:spPr>
          <a:xfrm>
            <a:off x="6747763" y="1618820"/>
            <a:ext cx="15632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M    1      2      3      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3FEB7AD-F7DA-479F-AEAF-5E591397178F}"/>
              </a:ext>
            </a:extLst>
          </p:cNvPr>
          <p:cNvSpPr txBox="1"/>
          <p:nvPr/>
        </p:nvSpPr>
        <p:spPr>
          <a:xfrm>
            <a:off x="2760618" y="4731348"/>
            <a:ext cx="648788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: Detection of purified p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lant-based SARS-CoV-2 RBD protein in immunoblot proved with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robed with rabbit polyclonal anti-SARS-CoV-2 (COVID-19) Spike RBD </a:t>
            </a:r>
            <a:r>
              <a:rPr lang="en-US" sz="1200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ntibody (a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and 6xHis HRP antibody. 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number above or below the protein band represents the densitometric intensity ratio of the protein in each lane.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, protein size marker; Lane 1, non-infiltrated total soluble protein (TSP); Lane 2, RBD-infiltrated TSP; Lane 3, recombinant RBD purified from tobacco plant leaves.</a:t>
            </a:r>
            <a:endParaRPr lang="en-US" sz="12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BDB078C-358D-48CD-BE22-78261D303EC0}"/>
              </a:ext>
            </a:extLst>
          </p:cNvPr>
          <p:cNvSpPr txBox="1"/>
          <p:nvPr/>
        </p:nvSpPr>
        <p:spPr>
          <a:xfrm>
            <a:off x="3197129" y="1555710"/>
            <a:ext cx="4346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7D02EE1-EC05-4BE8-9983-61473725EB26}"/>
              </a:ext>
            </a:extLst>
          </p:cNvPr>
          <p:cNvSpPr txBox="1"/>
          <p:nvPr/>
        </p:nvSpPr>
        <p:spPr>
          <a:xfrm>
            <a:off x="6169291" y="1572653"/>
            <a:ext cx="4346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.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D61B20B-E2FF-4ACF-B275-CB2B39BE5EC6}"/>
              </a:ext>
            </a:extLst>
          </p:cNvPr>
          <p:cNvSpPr txBox="1"/>
          <p:nvPr/>
        </p:nvSpPr>
        <p:spPr>
          <a:xfrm>
            <a:off x="4789703" y="3972223"/>
            <a:ext cx="4138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.0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68F452A-0411-4643-AF6C-3D4FA1D7D53C}"/>
              </a:ext>
            </a:extLst>
          </p:cNvPr>
          <p:cNvSpPr txBox="1"/>
          <p:nvPr/>
        </p:nvSpPr>
        <p:spPr>
          <a:xfrm>
            <a:off x="4872219" y="3335801"/>
            <a:ext cx="4138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8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829A846-D72B-4D43-B807-21327B96863C}"/>
              </a:ext>
            </a:extLst>
          </p:cNvPr>
          <p:cNvSpPr txBox="1"/>
          <p:nvPr/>
        </p:nvSpPr>
        <p:spPr>
          <a:xfrm>
            <a:off x="4884568" y="2772904"/>
            <a:ext cx="4138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.1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5A2AB16-CBF9-4F4D-8D51-40816A0AA40D}"/>
              </a:ext>
            </a:extLst>
          </p:cNvPr>
          <p:cNvSpPr txBox="1"/>
          <p:nvPr/>
        </p:nvSpPr>
        <p:spPr>
          <a:xfrm>
            <a:off x="4548575" y="2787885"/>
            <a:ext cx="4138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06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EC7E916-A391-4D0E-8346-878DF0F3490D}"/>
              </a:ext>
            </a:extLst>
          </p:cNvPr>
          <p:cNvSpPr txBox="1"/>
          <p:nvPr/>
        </p:nvSpPr>
        <p:spPr>
          <a:xfrm>
            <a:off x="4574085" y="3424307"/>
            <a:ext cx="4138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1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EA03E19-210B-4C79-AA1C-5666EDFE40A4}"/>
              </a:ext>
            </a:extLst>
          </p:cNvPr>
          <p:cNvSpPr txBox="1"/>
          <p:nvPr/>
        </p:nvSpPr>
        <p:spPr>
          <a:xfrm>
            <a:off x="7706970" y="2705151"/>
            <a:ext cx="4138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36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CE628A3-B919-4B1F-9CB2-7731E797CC21}"/>
              </a:ext>
            </a:extLst>
          </p:cNvPr>
          <p:cNvSpPr txBox="1"/>
          <p:nvPr/>
        </p:nvSpPr>
        <p:spPr>
          <a:xfrm>
            <a:off x="7693862" y="3300157"/>
            <a:ext cx="4138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.0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F386C69-6CE3-4DCD-86DD-95184C43B555}"/>
              </a:ext>
            </a:extLst>
          </p:cNvPr>
          <p:cNvSpPr txBox="1"/>
          <p:nvPr/>
        </p:nvSpPr>
        <p:spPr>
          <a:xfrm>
            <a:off x="7322478" y="3300157"/>
            <a:ext cx="4138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13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85F1FAD-FAE9-42B3-8DB8-DFF9B5920D8E}"/>
              </a:ext>
            </a:extLst>
          </p:cNvPr>
          <p:cNvSpPr txBox="1"/>
          <p:nvPr/>
        </p:nvSpPr>
        <p:spPr>
          <a:xfrm>
            <a:off x="3566345" y="266944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29CC9A4-E822-44FB-96CD-27393740786C}"/>
              </a:ext>
            </a:extLst>
          </p:cNvPr>
          <p:cNvSpPr txBox="1"/>
          <p:nvPr/>
        </p:nvSpPr>
        <p:spPr>
          <a:xfrm>
            <a:off x="3566345" y="2902256"/>
            <a:ext cx="3257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2D98E97-06E9-4ED0-8F70-3606E2A22286}"/>
              </a:ext>
            </a:extLst>
          </p:cNvPr>
          <p:cNvSpPr txBox="1"/>
          <p:nvPr/>
        </p:nvSpPr>
        <p:spPr>
          <a:xfrm>
            <a:off x="3566345" y="321106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AAAD6FE-6F5B-46BE-8611-D4AFA81D54A6}"/>
              </a:ext>
            </a:extLst>
          </p:cNvPr>
          <p:cNvSpPr txBox="1"/>
          <p:nvPr/>
        </p:nvSpPr>
        <p:spPr>
          <a:xfrm>
            <a:off x="3531079" y="240758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E8E6CF7-0019-43A9-B3FF-4B44C52DA6C3}"/>
              </a:ext>
            </a:extLst>
          </p:cNvPr>
          <p:cNvSpPr txBox="1"/>
          <p:nvPr/>
        </p:nvSpPr>
        <p:spPr>
          <a:xfrm>
            <a:off x="3531079" y="253135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직사각형 142">
            <a:extLst>
              <a:ext uri="{FF2B5EF4-FFF2-40B4-BE49-F238E27FC236}">
                <a16:creationId xmlns:a16="http://schemas.microsoft.com/office/drawing/2014/main" id="{659787FF-5515-4258-A0D6-AA17CC794B64}"/>
              </a:ext>
            </a:extLst>
          </p:cNvPr>
          <p:cNvSpPr/>
          <p:nvPr/>
        </p:nvSpPr>
        <p:spPr>
          <a:xfrm>
            <a:off x="3531079" y="2279999"/>
            <a:ext cx="35779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8479AE9-7206-4659-96E2-835A4091D4BB}"/>
              </a:ext>
            </a:extLst>
          </p:cNvPr>
          <p:cNvSpPr txBox="1"/>
          <p:nvPr/>
        </p:nvSpPr>
        <p:spPr>
          <a:xfrm>
            <a:off x="3566345" y="348051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17D7F12-23B2-4C5D-8BB4-BE36DF64C088}"/>
              </a:ext>
            </a:extLst>
          </p:cNvPr>
          <p:cNvSpPr txBox="1"/>
          <p:nvPr/>
        </p:nvSpPr>
        <p:spPr>
          <a:xfrm>
            <a:off x="3570512" y="3849188"/>
            <a:ext cx="3257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7B82FD4-D51F-4105-BDC3-07CFEFF8992E}"/>
              </a:ext>
            </a:extLst>
          </p:cNvPr>
          <p:cNvSpPr txBox="1"/>
          <p:nvPr/>
        </p:nvSpPr>
        <p:spPr>
          <a:xfrm>
            <a:off x="3566345" y="394209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직사각형 142">
            <a:extLst>
              <a:ext uri="{FF2B5EF4-FFF2-40B4-BE49-F238E27FC236}">
                <a16:creationId xmlns:a16="http://schemas.microsoft.com/office/drawing/2014/main" id="{82CC680F-F6BA-4A3F-8930-72A66A6195E3}"/>
              </a:ext>
            </a:extLst>
          </p:cNvPr>
          <p:cNvSpPr/>
          <p:nvPr/>
        </p:nvSpPr>
        <p:spPr>
          <a:xfrm>
            <a:off x="3531079" y="2098250"/>
            <a:ext cx="36740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02C58FFE-C2C9-4C5A-A42F-FB1544D95764}"/>
              </a:ext>
            </a:extLst>
          </p:cNvPr>
          <p:cNvSpPr txBox="1"/>
          <p:nvPr/>
        </p:nvSpPr>
        <p:spPr>
          <a:xfrm>
            <a:off x="6466947" y="270428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6EA06B2-CD33-4CE8-BEEE-9CB594955864}"/>
              </a:ext>
            </a:extLst>
          </p:cNvPr>
          <p:cNvSpPr txBox="1"/>
          <p:nvPr/>
        </p:nvSpPr>
        <p:spPr>
          <a:xfrm>
            <a:off x="6466947" y="2910965"/>
            <a:ext cx="3257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7DE4E2C-2667-4D34-8CA5-0C89B0BE0AC3}"/>
              </a:ext>
            </a:extLst>
          </p:cNvPr>
          <p:cNvSpPr txBox="1"/>
          <p:nvPr/>
        </p:nvSpPr>
        <p:spPr>
          <a:xfrm>
            <a:off x="6466947" y="319364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7504621-4279-4094-B7FA-668ECA54E462}"/>
              </a:ext>
            </a:extLst>
          </p:cNvPr>
          <p:cNvSpPr txBox="1"/>
          <p:nvPr/>
        </p:nvSpPr>
        <p:spPr>
          <a:xfrm>
            <a:off x="6431681" y="244242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13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57C9E695-5FD3-4E81-A40E-FDD1BB44AE22}"/>
              </a:ext>
            </a:extLst>
          </p:cNvPr>
          <p:cNvSpPr txBox="1"/>
          <p:nvPr/>
        </p:nvSpPr>
        <p:spPr>
          <a:xfrm>
            <a:off x="6431681" y="2566188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직사각형 142">
            <a:extLst>
              <a:ext uri="{FF2B5EF4-FFF2-40B4-BE49-F238E27FC236}">
                <a16:creationId xmlns:a16="http://schemas.microsoft.com/office/drawing/2014/main" id="{9F4BB84E-DE4D-4B48-94A6-8F325CA6E045}"/>
              </a:ext>
            </a:extLst>
          </p:cNvPr>
          <p:cNvSpPr/>
          <p:nvPr/>
        </p:nvSpPr>
        <p:spPr>
          <a:xfrm>
            <a:off x="6431681" y="2306126"/>
            <a:ext cx="35779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9EB05B20-78C2-4ED2-AF67-842E3D4A3EF7}"/>
              </a:ext>
            </a:extLst>
          </p:cNvPr>
          <p:cNvSpPr txBox="1"/>
          <p:nvPr/>
        </p:nvSpPr>
        <p:spPr>
          <a:xfrm>
            <a:off x="6466947" y="349793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114AA21-F98A-459D-93AF-8C2E0C850B3B}"/>
              </a:ext>
            </a:extLst>
          </p:cNvPr>
          <p:cNvSpPr txBox="1"/>
          <p:nvPr/>
        </p:nvSpPr>
        <p:spPr>
          <a:xfrm>
            <a:off x="6471114" y="3884024"/>
            <a:ext cx="3257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4EB335FB-5148-4F96-8EDB-EA782A3C441B}"/>
              </a:ext>
            </a:extLst>
          </p:cNvPr>
          <p:cNvSpPr txBox="1"/>
          <p:nvPr/>
        </p:nvSpPr>
        <p:spPr>
          <a:xfrm>
            <a:off x="6466947" y="397693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직사각형 142">
            <a:extLst>
              <a:ext uri="{FF2B5EF4-FFF2-40B4-BE49-F238E27FC236}">
                <a16:creationId xmlns:a16="http://schemas.microsoft.com/office/drawing/2014/main" id="{4912C5EE-D18C-4D84-A016-7FA48D886692}"/>
              </a:ext>
            </a:extLst>
          </p:cNvPr>
          <p:cNvSpPr/>
          <p:nvPr/>
        </p:nvSpPr>
        <p:spPr>
          <a:xfrm>
            <a:off x="6431681" y="2133086"/>
            <a:ext cx="36740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572514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직선 연결선 8">
            <a:extLst>
              <a:ext uri="{FF2B5EF4-FFF2-40B4-BE49-F238E27FC236}">
                <a16:creationId xmlns:a16="http://schemas.microsoft.com/office/drawing/2014/main" id="{AF554129-24C7-47CA-9EF2-5F254DB108CD}"/>
              </a:ext>
            </a:extLst>
          </p:cNvPr>
          <p:cNvCxnSpPr/>
          <p:nvPr/>
        </p:nvCxnSpPr>
        <p:spPr>
          <a:xfrm>
            <a:off x="3427912" y="528402"/>
            <a:ext cx="154616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직선 연결선 10">
            <a:extLst>
              <a:ext uri="{FF2B5EF4-FFF2-40B4-BE49-F238E27FC236}">
                <a16:creationId xmlns:a16="http://schemas.microsoft.com/office/drawing/2014/main" id="{A1C59771-B15B-43D8-A881-79F9D7877621}"/>
              </a:ext>
            </a:extLst>
          </p:cNvPr>
          <p:cNvCxnSpPr/>
          <p:nvPr/>
        </p:nvCxnSpPr>
        <p:spPr>
          <a:xfrm>
            <a:off x="5294195" y="531172"/>
            <a:ext cx="154616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직선 연결선 11">
            <a:extLst>
              <a:ext uri="{FF2B5EF4-FFF2-40B4-BE49-F238E27FC236}">
                <a16:creationId xmlns:a16="http://schemas.microsoft.com/office/drawing/2014/main" id="{9706991C-2F20-427F-A7EC-EF1EB1386DDE}"/>
              </a:ext>
            </a:extLst>
          </p:cNvPr>
          <p:cNvCxnSpPr/>
          <p:nvPr/>
        </p:nvCxnSpPr>
        <p:spPr>
          <a:xfrm>
            <a:off x="7117452" y="525630"/>
            <a:ext cx="154616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직선 연결선 12">
            <a:extLst>
              <a:ext uri="{FF2B5EF4-FFF2-40B4-BE49-F238E27FC236}">
                <a16:creationId xmlns:a16="http://schemas.microsoft.com/office/drawing/2014/main" id="{F9C22C06-FA9D-4E72-9969-975A103C813C}"/>
              </a:ext>
            </a:extLst>
          </p:cNvPr>
          <p:cNvCxnSpPr/>
          <p:nvPr/>
        </p:nvCxnSpPr>
        <p:spPr>
          <a:xfrm>
            <a:off x="8978714" y="528400"/>
            <a:ext cx="154616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D5A1E599-C1FD-436D-9AED-86287C489675}"/>
              </a:ext>
            </a:extLst>
          </p:cNvPr>
          <p:cNvSpPr txBox="1"/>
          <p:nvPr/>
        </p:nvSpPr>
        <p:spPr>
          <a:xfrm>
            <a:off x="3968239" y="223042"/>
            <a:ext cx="5645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RBD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6EE0AED-3F8D-4F34-B45E-C4DFE7D6CB45}"/>
              </a:ext>
            </a:extLst>
          </p:cNvPr>
          <p:cNvSpPr txBox="1"/>
          <p:nvPr/>
        </p:nvSpPr>
        <p:spPr>
          <a:xfrm>
            <a:off x="5501841" y="221929"/>
            <a:ext cx="10775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err="1">
                <a:latin typeface="Arial" panose="020B0604020202020204" pitchFamily="34" charset="0"/>
                <a:cs typeface="Arial" panose="020B0604020202020204" pitchFamily="34" charset="0"/>
              </a:rPr>
              <a:t>RBD+Alum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E010902-7BC5-43FD-9F45-645EB29AD082}"/>
              </a:ext>
            </a:extLst>
          </p:cNvPr>
          <p:cNvSpPr txBox="1"/>
          <p:nvPr/>
        </p:nvSpPr>
        <p:spPr>
          <a:xfrm>
            <a:off x="7142657" y="214148"/>
            <a:ext cx="15151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err="1">
                <a:latin typeface="Arial" panose="020B0604020202020204" pitchFamily="34" charset="0"/>
                <a:cs typeface="Arial" panose="020B0604020202020204" pitchFamily="34" charset="0"/>
              </a:rPr>
              <a:t>RBD+Alhydrogel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7C877B4-0962-49F1-BF1A-48231D1DF45C}"/>
              </a:ext>
            </a:extLst>
          </p:cNvPr>
          <p:cNvSpPr txBox="1"/>
          <p:nvPr/>
        </p:nvSpPr>
        <p:spPr>
          <a:xfrm>
            <a:off x="9061506" y="219714"/>
            <a:ext cx="13831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err="1">
                <a:latin typeface="Arial" panose="020B0604020202020204" pitchFamily="34" charset="0"/>
                <a:cs typeface="Arial" panose="020B0604020202020204" pitchFamily="34" charset="0"/>
              </a:rPr>
              <a:t>RBD+AddaVax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FD8A9C5-36EC-4023-A166-8937B2D31839}"/>
              </a:ext>
            </a:extLst>
          </p:cNvPr>
          <p:cNvSpPr txBox="1"/>
          <p:nvPr/>
        </p:nvSpPr>
        <p:spPr>
          <a:xfrm>
            <a:off x="455194" y="214148"/>
            <a:ext cx="9705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Serum dilution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7191AFC-51BC-4A16-8672-7ADD4470FA1E}"/>
              </a:ext>
            </a:extLst>
          </p:cNvPr>
          <p:cNvSpPr txBox="1"/>
          <p:nvPr/>
        </p:nvSpPr>
        <p:spPr>
          <a:xfrm>
            <a:off x="1042306" y="76199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BF0E3AC-7372-4058-81E0-9ABCE3A08264}"/>
              </a:ext>
            </a:extLst>
          </p:cNvPr>
          <p:cNvSpPr txBox="1"/>
          <p:nvPr/>
        </p:nvSpPr>
        <p:spPr>
          <a:xfrm>
            <a:off x="942920" y="1435001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160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179CDF2-5D8F-4450-B91A-FAC3690E154F}"/>
              </a:ext>
            </a:extLst>
          </p:cNvPr>
          <p:cNvSpPr txBox="1"/>
          <p:nvPr/>
        </p:nvSpPr>
        <p:spPr>
          <a:xfrm>
            <a:off x="942920" y="2061284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640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557D09D-F73B-4D94-88A4-56177004D04F}"/>
              </a:ext>
            </a:extLst>
          </p:cNvPr>
          <p:cNvSpPr txBox="1"/>
          <p:nvPr/>
        </p:nvSpPr>
        <p:spPr>
          <a:xfrm>
            <a:off x="793840" y="2655316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2,560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C3DF3DD-88BC-44C8-A3A9-371C3194808E}"/>
              </a:ext>
            </a:extLst>
          </p:cNvPr>
          <p:cNvSpPr txBox="1"/>
          <p:nvPr/>
        </p:nvSpPr>
        <p:spPr>
          <a:xfrm>
            <a:off x="694454" y="3281599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10,240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DFD1243-5A81-4C18-9CD2-AABBC4FBA4BF}"/>
              </a:ext>
            </a:extLst>
          </p:cNvPr>
          <p:cNvSpPr txBox="1"/>
          <p:nvPr/>
        </p:nvSpPr>
        <p:spPr>
          <a:xfrm>
            <a:off x="694454" y="3827791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40,960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76A8C20-F3E9-48C4-80D5-AA7EF24FA082}"/>
              </a:ext>
            </a:extLst>
          </p:cNvPr>
          <p:cNvSpPr txBox="1"/>
          <p:nvPr/>
        </p:nvSpPr>
        <p:spPr>
          <a:xfrm>
            <a:off x="595067" y="4434050"/>
            <a:ext cx="8306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163,840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9F7097E-860B-4A0E-A2F1-979D100E31F4}"/>
              </a:ext>
            </a:extLst>
          </p:cNvPr>
          <p:cNvSpPr txBox="1"/>
          <p:nvPr/>
        </p:nvSpPr>
        <p:spPr>
          <a:xfrm>
            <a:off x="595067" y="5073682"/>
            <a:ext cx="8306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655,360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직선 연결선 29">
            <a:extLst>
              <a:ext uri="{FF2B5EF4-FFF2-40B4-BE49-F238E27FC236}">
                <a16:creationId xmlns:a16="http://schemas.microsoft.com/office/drawing/2014/main" id="{759E9790-07A3-472C-8DB0-FECBD3033F9D}"/>
              </a:ext>
            </a:extLst>
          </p:cNvPr>
          <p:cNvCxnSpPr/>
          <p:nvPr/>
        </p:nvCxnSpPr>
        <p:spPr>
          <a:xfrm>
            <a:off x="1633503" y="540638"/>
            <a:ext cx="154616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3A85E600-AEA4-487A-BA55-D6F483485F5D}"/>
              </a:ext>
            </a:extLst>
          </p:cNvPr>
          <p:cNvSpPr txBox="1"/>
          <p:nvPr/>
        </p:nvSpPr>
        <p:spPr>
          <a:xfrm>
            <a:off x="1701428" y="17418"/>
            <a:ext cx="138852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Pre-immunized</a:t>
            </a:r>
          </a:p>
          <a:p>
            <a:pPr algn="ctr"/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sera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그림 3">
            <a:extLst>
              <a:ext uri="{FF2B5EF4-FFF2-40B4-BE49-F238E27FC236}">
                <a16:creationId xmlns:a16="http://schemas.microsoft.com/office/drawing/2014/main" id="{0C13E4F3-08A3-49A4-96F1-0E5BFCA7A84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colorTemperature colorTemp="7200"/>
                    </a14:imgEffect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19981"/>
          <a:stretch/>
        </p:blipFill>
        <p:spPr>
          <a:xfrm>
            <a:off x="1474733" y="675813"/>
            <a:ext cx="7312216" cy="4972877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0E649782-6E31-451B-A42F-047031B5FCA8}"/>
              </a:ext>
            </a:extLst>
          </p:cNvPr>
          <p:cNvSpPr txBox="1"/>
          <p:nvPr/>
        </p:nvSpPr>
        <p:spPr>
          <a:xfrm>
            <a:off x="10698130" y="214148"/>
            <a:ext cx="9705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Serum dilution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CF75DA9-8EE0-40DB-B2EF-BF0E24E8DD4F}"/>
              </a:ext>
            </a:extLst>
          </p:cNvPr>
          <p:cNvSpPr txBox="1"/>
          <p:nvPr/>
        </p:nvSpPr>
        <p:spPr>
          <a:xfrm>
            <a:off x="10698130" y="761993"/>
            <a:ext cx="8306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655,360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CEF021F-B59D-413C-B761-F22A2BEF3FB2}"/>
              </a:ext>
            </a:extLst>
          </p:cNvPr>
          <p:cNvSpPr txBox="1"/>
          <p:nvPr/>
        </p:nvSpPr>
        <p:spPr>
          <a:xfrm>
            <a:off x="10698130" y="1435001"/>
            <a:ext cx="8306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163,840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903BEEF-A59C-4E71-8E3E-7BC4919A71B7}"/>
              </a:ext>
            </a:extLst>
          </p:cNvPr>
          <p:cNvSpPr txBox="1"/>
          <p:nvPr/>
        </p:nvSpPr>
        <p:spPr>
          <a:xfrm>
            <a:off x="10698130" y="2061284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40,960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2D8F01C-E4BC-434C-8301-FDAAC3B6CAF8}"/>
              </a:ext>
            </a:extLst>
          </p:cNvPr>
          <p:cNvSpPr txBox="1"/>
          <p:nvPr/>
        </p:nvSpPr>
        <p:spPr>
          <a:xfrm>
            <a:off x="10698130" y="2655316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10,240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5C7B8A6-8174-49F6-A526-29D4599E81D2}"/>
              </a:ext>
            </a:extLst>
          </p:cNvPr>
          <p:cNvSpPr txBox="1"/>
          <p:nvPr/>
        </p:nvSpPr>
        <p:spPr>
          <a:xfrm>
            <a:off x="10698130" y="3281599"/>
            <a:ext cx="6319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2,560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462E1CD-1CBC-4441-ABEC-4EB7788D442B}"/>
              </a:ext>
            </a:extLst>
          </p:cNvPr>
          <p:cNvSpPr txBox="1"/>
          <p:nvPr/>
        </p:nvSpPr>
        <p:spPr>
          <a:xfrm>
            <a:off x="10698130" y="3827791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640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4E7F262-D34A-4F2F-ADC4-B9E317759A63}"/>
              </a:ext>
            </a:extLst>
          </p:cNvPr>
          <p:cNvSpPr txBox="1"/>
          <p:nvPr/>
        </p:nvSpPr>
        <p:spPr>
          <a:xfrm>
            <a:off x="10698130" y="4434050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160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EB5B794-BE5B-4FF7-AA62-0891FB17E3B1}"/>
              </a:ext>
            </a:extLst>
          </p:cNvPr>
          <p:cNvSpPr txBox="1"/>
          <p:nvPr/>
        </p:nvSpPr>
        <p:spPr>
          <a:xfrm>
            <a:off x="10698130" y="507368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그림 40">
            <a:extLst>
              <a:ext uri="{FF2B5EF4-FFF2-40B4-BE49-F238E27FC236}">
                <a16:creationId xmlns:a16="http://schemas.microsoft.com/office/drawing/2014/main" id="{AEE6A862-6A29-478D-AE5C-3EB565B58A5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colorTemperature colorTemp="7200"/>
                    </a14:imgEffect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0040"/>
          <a:stretch/>
        </p:blipFill>
        <p:spPr>
          <a:xfrm>
            <a:off x="8874208" y="675813"/>
            <a:ext cx="1823922" cy="4972877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1BBA44F7-2AA5-49A6-BBF7-E671B0B3BABF}"/>
              </a:ext>
            </a:extLst>
          </p:cNvPr>
          <p:cNvSpPr txBox="1"/>
          <p:nvPr/>
        </p:nvSpPr>
        <p:spPr>
          <a:xfrm>
            <a:off x="1184332" y="5877393"/>
            <a:ext cx="10287729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3: Representative panel of FRNT assay to demonstrate the potency of plant-based RBD immunized mouse sera to neutralize SARS-CoV-2. Sera samples were obtained from the mice immunized three times with plant-based RBD alone or RBD with adjuvants. The number of infected cells was counted and calculated FRNT50 as described in materials and methods. </a:t>
            </a:r>
          </a:p>
          <a:p>
            <a:endParaRPr lang="en-US" altLang="ko-K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91482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0</TotalTime>
  <Words>356</Words>
  <Application>Microsoft Office PowerPoint</Application>
  <PresentationFormat>Widescreen</PresentationFormat>
  <Paragraphs>7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Palatino Linotype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una Maya Maharjan</dc:creator>
  <cp:lastModifiedBy>Puna Maya Maharjan</cp:lastModifiedBy>
  <cp:revision>13</cp:revision>
  <dcterms:created xsi:type="dcterms:W3CDTF">2021-08-17T06:20:17Z</dcterms:created>
  <dcterms:modified xsi:type="dcterms:W3CDTF">2021-08-20T12:10:21Z</dcterms:modified>
</cp:coreProperties>
</file>